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75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B5E61-7688-EF8D-B4A8-CEBA0B94D2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C0D6AE-457B-F902-2B97-189AAA43FE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8F4CDB-EF49-D752-10F4-9E3DEC439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8C9E1C-0218-97F2-FDCA-59EDF8599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5C47AA-4C89-FC95-976F-EC727791C7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1919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AB183-C924-8A48-34B9-498CD1884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7EE7A8-E459-1B7E-048D-D3BB322622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AF8661-48E3-F308-ADCB-9908225B62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D51164-93D7-AED5-CF47-30C4CA1DF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CD7B94-4D73-9270-9D5D-A50AF3A8C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1543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D3EF11-2C83-8258-24C4-CDFB349902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DBF5BF-6B36-58F6-CA10-5DD26909DF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91D824-A985-1CB6-B090-1FBE65B52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4BCDBB-E990-A629-94C5-B1B733BB5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A51E7E-E559-27C4-2428-0A50D6B68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6223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4C1BA0-9C06-80AD-40FF-73073B0234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1C8DE6-B1B7-6317-D9E3-394E0871A6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D4796-7380-6DC5-F466-610475DA8C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4466F1-7328-583F-8828-173D95A7C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7F67FD-9496-FBDA-BD4A-681CED672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1989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0040A1-4858-D364-DAB0-23BDDACB5D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8F5B90-C383-F246-1CFB-5B90A5F2D3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F86700-2C12-9848-6CB6-88F0D15B3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D537E-6F2E-EDCF-24A6-F47C5B11C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124DC6-0806-3FC0-EA1B-6CEB4914F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54644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4F1C0-6C94-F97D-BCF2-EF96E0CBB7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B8218A-76AA-77DD-202C-4BC7FA25D9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641F5C-C10A-48EB-DAC8-455967F2B7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412731-7A42-7791-7F7B-8D1103890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A6B543-1D20-26D3-3BDD-932C5F972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D68BE8-D428-F98A-A825-3A662AB40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2540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97EBE-5186-F1F1-8D91-B6C32164A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9A5B0F-5FEF-CE02-FC90-B0F037ECB6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15B26C-659A-33F1-49D4-BD8CCA49D0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7B5D03-A596-2D05-3546-16B67B3A5A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834348-B520-4567-0481-365F624486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4114686-9D3F-BE5C-3847-CBE1387E3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41F9EB-395D-0A4B-6ACE-88BB78D76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A6384E-C8A1-3D76-03EE-DFD0E8465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8961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DD665B-FE3B-4511-4FCF-1F1FBAE186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776D57-3BCF-C050-2DED-476D6DE41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6D15A6-DB0F-9E18-EBCD-F12F908991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1E65E4-031D-6EC9-8BD0-A8BE08154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3143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69094C-EEB8-3A0C-F68E-68153286D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9BAEAEA-A427-5A51-C61F-BED59CB3AA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E97D64-3059-53B5-C522-DFC4E25A9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8557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4F222-88EC-C34C-1CD5-65FD6D5145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828967-EB18-785F-4B05-FECD6E5FDC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71CC9B-5300-F786-E237-8BCD8F79A1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153D3A-D138-7542-45EA-C9E9D4821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F96F33-FDF9-1DD0-4B24-7DDA5DFF8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C36BBE-883E-10A4-0826-FA1132505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6276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51AA7-4631-8461-B80F-A2A627B4CA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0F25891-23E4-7BF9-2C42-BECF3FCD1E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2A13B0-96FE-A183-2E73-328243C965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80FD40-81DE-14C2-10F0-8837525E2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76418F-C690-21D0-6D36-8622E996E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5DDFA8-B216-5EF7-4082-3DFE54D52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0649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00F9487-9D39-A0CD-BFF7-00D3B2FFAE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77EC68-D189-569B-5461-286EFEDD6B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CD1DD1-3A14-99DE-44F2-A11CFE4A85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33AF7-8848-418A-95A8-7AD04407C14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A5243F-962F-41AE-78FE-E8A5323059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C29258-7305-5ADD-0DE2-2FDC28FC8F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E281CF-F724-45BE-9146-1AAD866FAE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9841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89223A6-6751-1797-53D0-D45F8A363F00}"/>
              </a:ext>
            </a:extLst>
          </p:cNvPr>
          <p:cNvSpPr txBox="1"/>
          <p:nvPr/>
        </p:nvSpPr>
        <p:spPr>
          <a:xfrm>
            <a:off x="725863" y="4771936"/>
            <a:ext cx="11076495" cy="17095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800"/>
              </a:spcAft>
            </a:pP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C1 protein levels were measured in plasma at baseline in patients with </a:t>
            </a:r>
            <a:r>
              <a:rPr lang="en-GB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emorefractory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CRC enrolled in the randomized, phase 3 CORRECT trial (A). Optimized cut-off of the STC1 protein levels at baseline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sed on a Cox proportional hazards model for OS of patients enrolled in CORRECT (combined regorafenib and placebo cohorts [B]). 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CRC, metastatic colorectal cancer; OS, overall survival.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A3D7BC4-395E-0E41-9020-B69EACF0237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408"/>
          <a:stretch/>
        </p:blipFill>
        <p:spPr>
          <a:xfrm>
            <a:off x="725862" y="509637"/>
            <a:ext cx="3788141" cy="360987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196DD22-AD6F-C435-58EC-0910FFB200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6949" y="509637"/>
            <a:ext cx="6414994" cy="375127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869E8CC-9EBB-596B-84DA-60FB4C68D05F}"/>
              </a:ext>
            </a:extLst>
          </p:cNvPr>
          <p:cNvSpPr txBox="1"/>
          <p:nvPr/>
        </p:nvSpPr>
        <p:spPr>
          <a:xfrm>
            <a:off x="670057" y="191827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205816D-D54C-544A-6625-95E0E05D9D16}"/>
              </a:ext>
            </a:extLst>
          </p:cNvPr>
          <p:cNvSpPr txBox="1"/>
          <p:nvPr/>
        </p:nvSpPr>
        <p:spPr>
          <a:xfrm>
            <a:off x="5045664" y="193396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2228795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tophe Borg</dc:creator>
  <cp:lastModifiedBy>Christophe Borg</cp:lastModifiedBy>
  <cp:revision>1</cp:revision>
  <dcterms:created xsi:type="dcterms:W3CDTF">2024-11-02T17:40:39Z</dcterms:created>
  <dcterms:modified xsi:type="dcterms:W3CDTF">2024-11-02T17:44:08Z</dcterms:modified>
</cp:coreProperties>
</file>